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BEDBE1-9A37-4C46-AEF9-183871C873E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240848-0DB1-4FB1-9D3D-3CE0D93424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9932B3-C4A9-4233-A422-501010338D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7C9DAE-959C-4D95-8524-5FEC770D1E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9030F9-9FE3-484A-828F-D6B26A3F3C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C80FCE-9DBE-45BD-A837-F73231E625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9D7DBD-3C42-4C6D-970B-4163782542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7D276F-B1A7-4446-9763-D28DC1ABC1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D7AC60-F891-4106-A21E-DDF12846EB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9CE02D-022B-4060-A766-6295A76D58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791B85-891F-40C5-9E5F-9A19325F70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4305E1-B02C-47E1-8D08-C71275953E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8A385E-9C31-48BB-B5DF-5D735A20826D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7"/>
          <p:cNvSpPr/>
          <p:nvPr/>
        </p:nvSpPr>
        <p:spPr>
          <a:xfrm>
            <a:off x="762480" y="8134200"/>
            <a:ext cx="41785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: Median of concentration (amol/μl) (with 25th-75th percentile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: 4 cases could not be resected</a:t>
            </a:r>
            <a:r>
              <a:rPr b="0" lang="ja-JP" sz="1200" spc="-1" strike="noStrike">
                <a:solidFill>
                  <a:srgbClr val="000000"/>
                </a:solidFill>
                <a:latin typeface="Calibri"/>
                <a:ea typeface="Arial"/>
              </a:rPr>
              <a:t>　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Calibri"/>
                <a:ea typeface="Arial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: 5 cases with residual tumor after oper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テキスト ボックス 8"/>
          <p:cNvSpPr/>
          <p:nvPr/>
        </p:nvSpPr>
        <p:spPr>
          <a:xfrm>
            <a:off x="122040" y="108000"/>
            <a:ext cx="2835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</a:t>
            </a:r>
            <a:r>
              <a:rPr b="1" lang="ja-JP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549360" y="1044720"/>
          <a:ext cx="5832360" cy="6924600"/>
        </p:xfrm>
        <a:graphic>
          <a:graphicData uri="http://schemas.openxmlformats.org/drawingml/2006/table">
            <a:tbl>
              <a:tblPr/>
              <a:tblGrid>
                <a:gridCol w="539640"/>
                <a:gridCol w="695520"/>
                <a:gridCol w="536400"/>
                <a:gridCol w="1366920"/>
                <a:gridCol w="479520"/>
                <a:gridCol w="442800"/>
                <a:gridCol w="1181160"/>
                <a:gridCol w="590400"/>
              </a:tblGrid>
              <a:tr h="20952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ir-451 </a:t>
                      </a:r>
                      <a:r>
                        <a:rPr b="0" lang="en-US" sz="11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ir-486 </a:t>
                      </a:r>
                      <a:r>
                        <a:rPr b="0" lang="en-US" sz="11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252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x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0952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al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.03 (2.87-12.36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6 (0.11-0.38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952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emal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16 (2.66-10.34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8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5 (0.13-0.49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1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 gridSpan="2"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e (y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edia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ja-JP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　　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6</a:t>
                      </a:r>
                      <a:r>
                        <a:rPr b="0" lang="ja-JP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　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(35-87)</a:t>
                      </a:r>
                      <a:r>
                        <a:rPr b="0" lang="ja-JP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　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952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&lt;6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.88 (2.72-12.45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8 (0.19-0.33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952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0≦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.09 (2.74-11.06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6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2 (0.10-0.49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4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 gridSpan="3"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umor size (cm)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952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&lt;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.03 (2.66-13.63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8 (0.14-0.39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988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≦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17 (2.80-9.78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6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2 (0.11-0.44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1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 gridSpan="2"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istological typ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952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el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.53 (2.72-12.46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0 (0.13-0.47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952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oo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43 (2.77-10.23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7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1 (0.12-0.37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 gridSpan="3"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ymphatic invasion </a:t>
                      </a:r>
                      <a:r>
                        <a:rPr b="0" lang="en-US" sz="11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952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.46 (4.15-13.64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0 (0.15-0.38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420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03 (2.42-10.28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39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3 (0.08-0.56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1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 gridSpan="3"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enous invasion </a:t>
                      </a:r>
                      <a:r>
                        <a:rPr b="0" lang="en-US" sz="11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952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.04 (2.66-13.63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8 (0.15-0.39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952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.09 (2.96-11.42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6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6 (0.10-0.50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5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 gridSpan="2"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T stage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092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, sm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.89 (3.08-13.63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1(0.16-0.57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Other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17 (2.70-10.52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0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9 (0.11-0.41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2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 gridSpan="2"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N stag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952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.96 (3.80-13.34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0 (0.16-0.57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952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03 (2.66-10.63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5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1 (0.11-0.44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3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880">
                <a:tc gridSpan="2"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TMN stag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952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Ⅰ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Ⅱ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.03 (4.15-13.63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1 (0.14-0.43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420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Ⅲ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Ⅳ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86 (2.53-9.29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16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9 (0.08-0.38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3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 gridSpan="2"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currence </a:t>
                      </a:r>
                      <a:r>
                        <a:rPr b="0" lang="en-US" sz="1100" spc="-1" strike="noStrike" baseline="30000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,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952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.04 (3.47-13.05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2 (0.14-0.56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952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.02 (2.98-11.33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4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3 (0.12-0.33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2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2520">
                <a:tc gridSpan="2"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sidual tumo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952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.04 (3.04-12.45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1 (0.14-0.46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14560"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74 (1.70-4.89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11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0 (0.07-0.22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680" rIns="4680" tIns="4680" bIns="0" anchor="ctr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3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18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4680" marR="46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テキスト ボックス 5"/>
          <p:cNvSpPr/>
          <p:nvPr/>
        </p:nvSpPr>
        <p:spPr>
          <a:xfrm>
            <a:off x="558000" y="509760"/>
            <a:ext cx="5877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rrelation between pre-operative plasma miR-451 or miR-486 concentration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nd clinicopathologic features in gastric cancer patien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7-23T08:39:01Z</dcterms:created>
  <dc:creator>hirotaka</dc:creator>
  <dc:description/>
  <dc:language>en-US</dc:language>
  <cp:lastModifiedBy>hirotaka</cp:lastModifiedBy>
  <dcterms:modified xsi:type="dcterms:W3CDTF">2011-10-13T10:01:15Z</dcterms:modified>
  <cp:revision>14</cp:revision>
  <dc:subject/>
  <dc:title>スライド 1</dc:title>
</cp:coreProperties>
</file>